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906000" cy="6858000" type="A4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312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="" xmlns:p14="http://schemas.microsoft.com/office/powerpoint/2010/main">
          <a:srgbClr val="FF0000"/>
        </p14:laserClr>
      </p:ext>
      <p:ext uri="{2FDB2607-1784-4EEB-B798-7EB5836EED8A}">
        <p14:showMediaCtrls xmlns="" xmlns:p14="http://schemas.microsoft.com/office/powerpoint/2010/main" val="1"/>
      </p:ext>
    </p:extLst>
  </p:showPr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82" d="100"/>
          <a:sy n="82" d="100"/>
        </p:scale>
        <p:origin x="-1138" y="-77"/>
      </p:cViewPr>
      <p:guideLst>
        <p:guide orient="horz" pos="2160"/>
        <p:guide pos="312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742950" y="2130426"/>
            <a:ext cx="8420100" cy="1470025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485900" y="3886200"/>
            <a:ext cx="69342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6AA895-F64C-438B-AA50-01D9E4001522}" type="datetimeFigureOut">
              <a:rPr lang="es-ES" smtClean="0"/>
              <a:pPr/>
              <a:t>18/09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B56DDC-4AD7-475B-9BB9-2C7105DF4492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6AA895-F64C-438B-AA50-01D9E4001522}" type="datetimeFigureOut">
              <a:rPr lang="es-ES" smtClean="0"/>
              <a:pPr/>
              <a:t>18/09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B56DDC-4AD7-475B-9BB9-2C7105DF4492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7780337" y="274639"/>
            <a:ext cx="2414588" cy="5851525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536575" y="274639"/>
            <a:ext cx="7078663" cy="5851525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6AA895-F64C-438B-AA50-01D9E4001522}" type="datetimeFigureOut">
              <a:rPr lang="es-ES" smtClean="0"/>
              <a:pPr/>
              <a:t>18/09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B56DDC-4AD7-475B-9BB9-2C7105DF4492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6AA895-F64C-438B-AA50-01D9E4001522}" type="datetimeFigureOut">
              <a:rPr lang="es-ES" smtClean="0"/>
              <a:pPr/>
              <a:t>18/09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B56DDC-4AD7-475B-9BB9-2C7105DF4492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782506" y="4406901"/>
            <a:ext cx="84201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782506" y="2906713"/>
            <a:ext cx="84201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6AA895-F64C-438B-AA50-01D9E4001522}" type="datetimeFigureOut">
              <a:rPr lang="es-ES" smtClean="0"/>
              <a:pPr/>
              <a:t>18/09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B56DDC-4AD7-475B-9BB9-2C7105DF4492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536575" y="1600201"/>
            <a:ext cx="4746625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5448300" y="1600201"/>
            <a:ext cx="4746625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6AA895-F64C-438B-AA50-01D9E4001522}" type="datetimeFigureOut">
              <a:rPr lang="es-ES" smtClean="0"/>
              <a:pPr/>
              <a:t>18/09/2019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B56DDC-4AD7-475B-9BB9-2C7105DF4492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95300" y="1535113"/>
            <a:ext cx="437687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95300" y="2174875"/>
            <a:ext cx="437687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5032111" y="1535113"/>
            <a:ext cx="437859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5032111" y="2174875"/>
            <a:ext cx="437859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6AA895-F64C-438B-AA50-01D9E4001522}" type="datetimeFigureOut">
              <a:rPr lang="es-ES" smtClean="0"/>
              <a:pPr/>
              <a:t>18/09/2019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B56DDC-4AD7-475B-9BB9-2C7105DF4492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6AA895-F64C-438B-AA50-01D9E4001522}" type="datetimeFigureOut">
              <a:rPr lang="es-ES" smtClean="0"/>
              <a:pPr/>
              <a:t>18/09/2019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B56DDC-4AD7-475B-9BB9-2C7105DF4492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6AA895-F64C-438B-AA50-01D9E4001522}" type="datetimeFigureOut">
              <a:rPr lang="es-ES" smtClean="0"/>
              <a:pPr/>
              <a:t>18/09/2019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B56DDC-4AD7-475B-9BB9-2C7105DF4492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95300" y="273050"/>
            <a:ext cx="3259006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3872971" y="273051"/>
            <a:ext cx="5537729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495300" y="1435101"/>
            <a:ext cx="3259006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6AA895-F64C-438B-AA50-01D9E4001522}" type="datetimeFigureOut">
              <a:rPr lang="es-ES" smtClean="0"/>
              <a:pPr/>
              <a:t>18/09/2019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B56DDC-4AD7-475B-9BB9-2C7105DF4492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941645" y="4800600"/>
            <a:ext cx="59436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941645" y="612775"/>
            <a:ext cx="59436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941645" y="5367338"/>
            <a:ext cx="59436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6AA895-F64C-438B-AA50-01D9E4001522}" type="datetimeFigureOut">
              <a:rPr lang="es-ES" smtClean="0"/>
              <a:pPr/>
              <a:t>18/09/2019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B56DDC-4AD7-475B-9BB9-2C7105DF4492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95300" y="1600201"/>
            <a:ext cx="89154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495300" y="6356351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6AA895-F64C-438B-AA50-01D9E4001522}" type="datetimeFigureOut">
              <a:rPr lang="es-ES" smtClean="0"/>
              <a:pPr/>
              <a:t>18/09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3384550" y="6356351"/>
            <a:ext cx="31369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7099300" y="6356351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B56DDC-4AD7-475B-9BB9-2C7105DF4492}" type="slidenum">
              <a:rPr lang="es-ES" smtClean="0"/>
              <a:pPr/>
              <a:t>‹Nº›</a:t>
            </a:fld>
            <a:endParaRPr lang="es-E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203624" y="534775"/>
            <a:ext cx="9610725" cy="48926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4" name="Rectangle 189"/>
          <p:cNvSpPr>
            <a:spLocks noChangeArrowheads="1"/>
          </p:cNvSpPr>
          <p:nvPr/>
        </p:nvSpPr>
        <p:spPr bwMode="auto">
          <a:xfrm>
            <a:off x="0" y="0"/>
            <a:ext cx="1313996" cy="45318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72000" tIns="72000" rIns="72000" bIns="72000">
            <a:spAutoFit/>
          </a:bodyPr>
          <a:lstStyle/>
          <a:p>
            <a:r>
              <a:rPr lang="en-GB" sz="2000" b="1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Figure S2</a:t>
            </a:r>
            <a:endParaRPr lang="en-GB" sz="2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25" name="Rectangle 1"/>
          <p:cNvSpPr>
            <a:spLocks noChangeArrowheads="1"/>
          </p:cNvSpPr>
          <p:nvPr/>
        </p:nvSpPr>
        <p:spPr bwMode="auto">
          <a:xfrm>
            <a:off x="571501" y="5617029"/>
            <a:ext cx="8795453" cy="10156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Fig. S2. Purification of the Twi1 recombinant protein. (A)</a:t>
            </a:r>
            <a:r>
              <a:rPr kumimoji="0" lang="en-GB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 Elution profiles of nickel affinity </a:t>
            </a:r>
            <a:r>
              <a:rPr kumimoji="0" lang="en-GB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chromathography</a:t>
            </a:r>
            <a:r>
              <a:rPr kumimoji="0" lang="en-GB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 with </a:t>
            </a:r>
            <a:r>
              <a:rPr kumimoji="0" lang="en-GB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imidazole</a:t>
            </a:r>
            <a:r>
              <a:rPr kumimoji="0" lang="en-GB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 gradient from the crude extract of the control plants </a:t>
            </a:r>
            <a:r>
              <a:rPr kumimoji="0" lang="en-GB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agroinoculated</a:t>
            </a:r>
            <a:r>
              <a:rPr kumimoji="0" lang="en-GB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 with the pGWB8 empty vector</a:t>
            </a:r>
            <a:r>
              <a:rPr kumimoji="0" lang="en-GB" sz="12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 </a:t>
            </a:r>
            <a:r>
              <a:rPr kumimoji="0" lang="en-GB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(Control) and the plants </a:t>
            </a:r>
            <a:r>
              <a:rPr kumimoji="0" lang="en-GB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agroinoculated</a:t>
            </a:r>
            <a:r>
              <a:rPr kumimoji="0" lang="en-GB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 with pGWB8_</a:t>
            </a:r>
            <a:r>
              <a:rPr kumimoji="0" lang="en-GB" sz="12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Twi1</a:t>
            </a:r>
            <a:r>
              <a:rPr kumimoji="0" lang="en-GB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 construction (Twi1-His</a:t>
            </a:r>
            <a:r>
              <a:rPr kumimoji="0" lang="en-GB" sz="1200" b="0" i="0" u="none" strike="noStrike" cap="none" normalizeH="0" baseline="-3000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6</a:t>
            </a:r>
            <a:r>
              <a:rPr kumimoji="0" lang="en-GB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). </a:t>
            </a:r>
            <a:r>
              <a:rPr kumimoji="0" lang="en-GB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(B) </a:t>
            </a:r>
            <a:r>
              <a:rPr kumimoji="0" lang="en-GB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The SDS/PAGE analysis of the protein content in the purified fractions. The protein band present in the fractions from 13 to 15 and from 16 to 19 corresponds to the His-tagged Twi1 recombinant protein.</a:t>
            </a:r>
            <a:endParaRPr kumimoji="0" lang="en-GB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91</Words>
  <Application>Microsoft Office PowerPoint</Application>
  <PresentationFormat>A4 (210 x 297 mm)</PresentationFormat>
  <Paragraphs>2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2" baseType="lpstr">
      <vt:lpstr>Tema de Office</vt:lpstr>
      <vt:lpstr>Diapositiva 1</vt:lpstr>
    </vt:vector>
  </TitlesOfParts>
  <Company>UPV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irodrig</dc:creator>
  <cp:lastModifiedBy>irodrig</cp:lastModifiedBy>
  <cp:revision>5</cp:revision>
  <dcterms:created xsi:type="dcterms:W3CDTF">2018-09-12T15:17:25Z</dcterms:created>
  <dcterms:modified xsi:type="dcterms:W3CDTF">2019-09-18T08:53:18Z</dcterms:modified>
</cp:coreProperties>
</file>